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26ACEDE5-4344-1001-A546-33FD1F68A4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25894" y="3564715"/>
            <a:ext cx="9940212" cy="746027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 Forest plot of APACHEII score in relation to refeeding syndrome in acutely ill patients 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E3F82FB7-CD83-BE94-FF92-C851829A885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814513" y="845976"/>
            <a:ext cx="8562975" cy="2409987"/>
            <a:chOff x="1143" y="797"/>
            <a:chExt cx="5394" cy="1254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50AF5E00-82A5-4EF8-1923-F667D1F44210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43" y="797"/>
              <a:ext cx="5394" cy="12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47D9AB88-AD01-365F-E1CD-4322D0EBD0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3" y="797"/>
              <a:ext cx="5394" cy="1254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24E7D052-CE4A-3C8B-D8B9-159BCAA4DD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43" y="990"/>
              <a:ext cx="539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DD3491C6-0B59-9E46-43EC-23D5550FB5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917"/>
              <a:ext cx="68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E1084622-9082-8546-3ABA-39087D317C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024"/>
              <a:ext cx="30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ih 20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D03854A7-2F7B-7782-D637-1858AB3932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120"/>
              <a:ext cx="35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Qiu 20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734C33C6-8756-E48B-9315-0419230CB9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217"/>
              <a:ext cx="30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52BB17F4-7576-2E10-3326-2C984CD86A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313"/>
              <a:ext cx="332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Xu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415E1442-4C3D-B860-7716-01FCCE41DA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410"/>
              <a:ext cx="4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17C604E6-2070-FB6D-3197-EF10D2DBCF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506"/>
              <a:ext cx="4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6ADB84D8-5C1B-9983-0D0D-409827D0A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689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F60FA987-62A2-648F-7E6F-3532C74085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794"/>
              <a:ext cx="254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Tau² = 2.73; Chi² = 44.29, df = 5 (P &lt; 0.00001); I² = 89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9C71B59F-9062-D113-5EA0-D2FB18775F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3" y="1892"/>
              <a:ext cx="14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3.63 (P = 0.0003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F4BA8C15-7D9D-877D-AD3B-C627B74F3F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6" y="917"/>
              <a:ext cx="22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45C4A1EA-C8C8-EA84-F8FD-F6ED972B4C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2" y="1024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.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49CB7219-C350-E4E8-F5A8-C163C654DF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2" y="1120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.4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84DB1C4E-A743-08F5-F797-CA95BBB492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2" y="1217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.1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4B59C78A-C9D6-7AA1-FC30-2FD451C41D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2" y="1313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.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5C91FC7C-368E-209B-E3DE-41C7CEC4DF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2" y="1410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0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663470A5-3D6F-AB78-2EF2-53A32EA70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2" y="1506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9.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DB2912E1-B758-1F3A-4494-F5C9BA9C22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6" y="917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46F4687D-1326-A5E2-8AF8-2A3368D710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2" y="1024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45B3A02B-8C49-68C0-29D4-92E38CBDE3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2" y="1120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8496EA8B-A6FC-5440-332D-70A936D31C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2" y="121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2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B1B15773-B180-D52A-FF21-EDAC7F621C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2" y="1313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91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BB2A4128-7BE4-974B-FC31-84D3F21B31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2" y="141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9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41218C53-C69F-0332-98D0-C7DF327BAF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2" y="1506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0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F9F4A212-5293-A112-605A-462F3957EF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2" y="917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3AA81418-8F45-AD70-F0DB-7B3DAF29D6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0" y="102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7AE70D79-55FC-79D8-BC23-1D6B11BA56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" y="1120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EDEBE745-90C5-3F4A-E29C-292E07D1AC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0" y="1217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2F8F4FAB-7E6D-8D38-AC20-45B7A1FE1C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" y="1313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D7B06348-9AF7-5D7D-3D4E-F39755970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" y="141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03E4BCC4-96D5-DA50-408E-4E38FFA965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0" y="1506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31AE30B7-C72C-EDC5-F6EF-477A7D4F8C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" y="1689"/>
              <a:ext cx="1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76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0D82F256-AA9D-EAB1-0BD1-1971121A1E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1" y="917"/>
              <a:ext cx="21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05844C24-7225-9C02-6A32-3EC3AE0E21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7" y="1024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.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3419B944-123F-299D-A1BB-EFB2741C7D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1120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9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6C286B6E-6E6E-9A1E-D58D-E2229B1E33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1217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.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63006887-86F9-54C0-006C-7CB8A28A63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7" y="1313"/>
              <a:ext cx="27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12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AF3E85DB-612F-915C-42E1-F486CF54E2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1410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.8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E360C7FE-928D-0382-9EDC-F7780D1CF8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1506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.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746E0A77-07F9-A481-2D12-8E30A3FFCA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1" y="917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FE3C26BF-0C14-5575-277D-A4F16F6C58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" y="1024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3C77777E-A8A9-0232-5F5A-4D0316D4AA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7" y="1120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9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6401E102-A9B7-1F76-B8AB-87E73377E9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7" y="121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A2EBE85B-533A-4286-334A-1869D04735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" y="1313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.7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50293D32-85BB-4422-B1D9-07A4040EAD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" y="1410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578800CD-0985-70CE-8297-979575116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7" y="1506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7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79C4C79E-1567-B301-ACCF-27A38999AB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3" y="917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947E1210-0370-279F-CF8C-884110011F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1" y="102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42E150A2-6642-B495-F88E-9C4400CEA5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1" y="1120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5C4A1FF5-5956-97BD-00F3-C821D80177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1" y="1217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D6332DA0-AA32-8CE1-B910-6FC5961B8D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1" y="1313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6A439EDA-1E53-07C6-90B9-51FA6186CA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1" y="141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B54597F3-DE12-2AC4-1FD3-B46A80565F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1" y="1506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7645F5F7-9554-FE7D-80D8-892634EDD5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3" y="1689"/>
              <a:ext cx="19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B13B4E7A-D52A-24D0-99CC-DBE127F37C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2" y="917"/>
              <a:ext cx="2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9B2033BA-FCAB-8FEB-00E5-D6C0ED88EA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" y="1024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5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0023CBFA-2A7F-E45C-B779-5B6D1A740D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" y="1120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D51BE428-F4E6-5E21-6D5C-B14617BE80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" y="1217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.4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AE6020C3-6724-D98E-EBFE-B57E0E0C00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" y="1313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.4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553A0201-F7C1-B79E-9101-B46A6299A2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" y="1410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3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28FB0A57-B46A-346B-84A7-03AF4551D4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" y="1506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.8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EE64AA29-CA45-5558-1438-018F935111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2" y="1689"/>
              <a:ext cx="27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CF97BFF1-EC8D-A6EE-CCA2-76B849CB27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2" y="917"/>
              <a:ext cx="7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003880CE-A70A-6C0B-5A6E-04FF3FF63FC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4" y="1024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90 [0.28, 3.52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7E5B124D-1E3C-A2F1-EA2D-4878FB24BA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0" y="1120"/>
              <a:ext cx="63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8 [-0.22, 1.1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B7D20547-0C30-1612-9319-F00D600C24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4" y="1217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80 [0.39, 3.21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206D66DB-09EA-2173-2527-61225178F8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4" y="1313"/>
              <a:ext cx="607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6 [3.75, 7.56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B7ED150A-9B94-B813-5F0F-BDBCB2F26D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4" y="1410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16 [2.02, 4.30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D9292049-EE15-9103-67CC-EAB3928644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4" y="1506"/>
              <a:ext cx="55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.41 [2.43, 4.39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BD72E2E1-EE20-B6C7-2EE5-DA9CEF18F9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0" y="1689"/>
              <a:ext cx="563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2.65 [1.22, 4.0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A895FF69-FE12-CD29-215F-AAE9DCBDEE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2" y="820"/>
              <a:ext cx="447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6B6978DB-EF92-FBDB-CAA6-BFEAEC037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" y="820"/>
              <a:ext cx="62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2F41F915-BF09-90D5-85A9-36F7EF61EB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" y="820"/>
              <a:ext cx="6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F353B7AE-5A1E-1173-E7A2-7EE5C9FCA3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9" y="820"/>
              <a:ext cx="6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08760452-0289-806B-368E-A32800F6B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6" y="917"/>
              <a:ext cx="7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Line 82">
              <a:extLst>
                <a:ext uri="{FF2B5EF4-FFF2-40B4-BE49-F238E27FC236}">
                  <a16:creationId xmlns:a16="http://schemas.microsoft.com/office/drawing/2014/main" id="{20AD966B-4CD4-CB2B-3F1A-7ECE471586D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8" y="990"/>
              <a:ext cx="0" cy="82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Line 83">
              <a:extLst>
                <a:ext uri="{FF2B5EF4-FFF2-40B4-BE49-F238E27FC236}">
                  <a16:creationId xmlns:a16="http://schemas.microsoft.com/office/drawing/2014/main" id="{C00B4E73-71D1-3319-9EFD-F76CC436F6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04" y="1038"/>
              <a:ext cx="422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FAD41149-304C-51F6-667E-811DC9D23C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1" y="1031"/>
              <a:ext cx="27" cy="26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Line 85">
              <a:extLst>
                <a:ext uri="{FF2B5EF4-FFF2-40B4-BE49-F238E27FC236}">
                  <a16:creationId xmlns:a16="http://schemas.microsoft.com/office/drawing/2014/main" id="{594B6232-FF1C-0C31-1488-F11F2B63DC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39" y="1135"/>
              <a:ext cx="182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03C1DD65-0623-C8C5-83A6-59AEF9270B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15" y="1126"/>
              <a:ext cx="30" cy="29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Line 87">
              <a:extLst>
                <a:ext uri="{FF2B5EF4-FFF2-40B4-BE49-F238E27FC236}">
                  <a16:creationId xmlns:a16="http://schemas.microsoft.com/office/drawing/2014/main" id="{347E7158-C262-3BA1-A2AE-3AF72A067F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19" y="1231"/>
              <a:ext cx="36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1" name="Rectangle 88">
              <a:extLst>
                <a:ext uri="{FF2B5EF4-FFF2-40B4-BE49-F238E27FC236}">
                  <a16:creationId xmlns:a16="http://schemas.microsoft.com/office/drawing/2014/main" id="{A19AC554-701D-152D-F480-D74C5B931E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8" y="1223"/>
              <a:ext cx="27" cy="28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Line 89">
              <a:extLst>
                <a:ext uri="{FF2B5EF4-FFF2-40B4-BE49-F238E27FC236}">
                  <a16:creationId xmlns:a16="http://schemas.microsoft.com/office/drawing/2014/main" id="{560D826D-4054-9299-21BE-E1EC53212E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55" y="1328"/>
              <a:ext cx="49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3" name="Rectangle 90">
              <a:extLst>
                <a:ext uri="{FF2B5EF4-FFF2-40B4-BE49-F238E27FC236}">
                  <a16:creationId xmlns:a16="http://schemas.microsoft.com/office/drawing/2014/main" id="{17FED1B2-82D4-42B3-7DBC-272B78D09F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0" y="1320"/>
              <a:ext cx="26" cy="27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Line 91">
              <a:extLst>
                <a:ext uri="{FF2B5EF4-FFF2-40B4-BE49-F238E27FC236}">
                  <a16:creationId xmlns:a16="http://schemas.microsoft.com/office/drawing/2014/main" id="{20C46021-1D8D-4530-3F9E-139D534926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29" y="1424"/>
              <a:ext cx="29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Rectangle 92">
              <a:extLst>
                <a:ext uri="{FF2B5EF4-FFF2-40B4-BE49-F238E27FC236}">
                  <a16:creationId xmlns:a16="http://schemas.microsoft.com/office/drawing/2014/main" id="{2E0E28B0-BA70-148E-15EF-18A3C101CD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4" y="1416"/>
              <a:ext cx="29" cy="28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Line 93">
              <a:extLst>
                <a:ext uri="{FF2B5EF4-FFF2-40B4-BE49-F238E27FC236}">
                  <a16:creationId xmlns:a16="http://schemas.microsoft.com/office/drawing/2014/main" id="{D773573D-A7F6-10EA-98D8-3B12A158E16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83" y="1520"/>
              <a:ext cx="25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7" name="Rectangle 94">
              <a:extLst>
                <a:ext uri="{FF2B5EF4-FFF2-40B4-BE49-F238E27FC236}">
                  <a16:creationId xmlns:a16="http://schemas.microsoft.com/office/drawing/2014/main" id="{CABB0E4E-644C-6132-584E-9E020A6723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6" y="1512"/>
              <a:ext cx="29" cy="29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Freeform 95">
              <a:extLst>
                <a:ext uri="{FF2B5EF4-FFF2-40B4-BE49-F238E27FC236}">
                  <a16:creationId xmlns:a16="http://schemas.microsoft.com/office/drawing/2014/main" id="{311E9C22-ABB4-4400-6B1E-2D0FEA4CCA39}"/>
                </a:ext>
              </a:extLst>
            </p:cNvPr>
            <p:cNvSpPr>
              <a:spLocks/>
            </p:cNvSpPr>
            <p:nvPr/>
          </p:nvSpPr>
          <p:spPr bwMode="auto">
            <a:xfrm>
              <a:off x="5624" y="1671"/>
              <a:ext cx="372" cy="85"/>
            </a:xfrm>
            <a:custGeom>
              <a:avLst/>
              <a:gdLst>
                <a:gd name="T0" fmla="*/ 620 w 1240"/>
                <a:gd name="T1" fmla="*/ 280 h 280"/>
                <a:gd name="T2" fmla="*/ 0 w 1240"/>
                <a:gd name="T3" fmla="*/ 140 h 280"/>
                <a:gd name="T4" fmla="*/ 620 w 1240"/>
                <a:gd name="T5" fmla="*/ 0 h 280"/>
                <a:gd name="T6" fmla="*/ 1240 w 1240"/>
                <a:gd name="T7" fmla="*/ 140 h 280"/>
                <a:gd name="T8" fmla="*/ 620 w 124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240" h="280">
                  <a:moveTo>
                    <a:pt x="620" y="280"/>
                  </a:moveTo>
                  <a:lnTo>
                    <a:pt x="0" y="140"/>
                  </a:lnTo>
                  <a:lnTo>
                    <a:pt x="620" y="0"/>
                  </a:lnTo>
                  <a:lnTo>
                    <a:pt x="1240" y="140"/>
                  </a:lnTo>
                  <a:lnTo>
                    <a:pt x="62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id="{70B9F329-2183-CA6D-3937-C9B06A2B9B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65" y="1810"/>
              <a:ext cx="2006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Line 97">
              <a:extLst>
                <a:ext uri="{FF2B5EF4-FFF2-40B4-BE49-F238E27FC236}">
                  <a16:creationId xmlns:a16="http://schemas.microsoft.com/office/drawing/2014/main" id="{008354E4-563C-6EDC-104B-C860375380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48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1" name="Rectangle 98">
              <a:extLst>
                <a:ext uri="{FF2B5EF4-FFF2-40B4-BE49-F238E27FC236}">
                  <a16:creationId xmlns:a16="http://schemas.microsoft.com/office/drawing/2014/main" id="{C1B11B11-747B-B823-7012-C8D351D521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6" y="1844"/>
              <a:ext cx="9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Line 99">
              <a:extLst>
                <a:ext uri="{FF2B5EF4-FFF2-40B4-BE49-F238E27FC236}">
                  <a16:creationId xmlns:a16="http://schemas.microsoft.com/office/drawing/2014/main" id="{55AD27D7-C6AA-D19F-C9FB-9AC69F971C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8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" name="Rectangle 100">
              <a:extLst>
                <a:ext uri="{FF2B5EF4-FFF2-40B4-BE49-F238E27FC236}">
                  <a16:creationId xmlns:a16="http://schemas.microsoft.com/office/drawing/2014/main" id="{58C40EC6-8C39-D6A0-9EA1-47FCFFFFB5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6" y="1844"/>
              <a:ext cx="9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Line 101">
              <a:extLst>
                <a:ext uri="{FF2B5EF4-FFF2-40B4-BE49-F238E27FC236}">
                  <a16:creationId xmlns:a16="http://schemas.microsoft.com/office/drawing/2014/main" id="{6B3D53D0-4B8C-9101-FAD5-AA235C5EA0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68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" name="Rectangle 102">
              <a:extLst>
                <a:ext uri="{FF2B5EF4-FFF2-40B4-BE49-F238E27FC236}">
                  <a16:creationId xmlns:a16="http://schemas.microsoft.com/office/drawing/2014/main" id="{7AB1B0E5-9E9B-0603-913E-54F9DCF455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8" y="1844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Line 103">
              <a:extLst>
                <a:ext uri="{FF2B5EF4-FFF2-40B4-BE49-F238E27FC236}">
                  <a16:creationId xmlns:a16="http://schemas.microsoft.com/office/drawing/2014/main" id="{139C84EA-FCB1-19C8-1B8A-F3A4D0D385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28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D5AFA6D6-29C3-FE12-2D59-3D617559A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8" y="1844"/>
              <a:ext cx="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Line 105">
              <a:extLst>
                <a:ext uri="{FF2B5EF4-FFF2-40B4-BE49-F238E27FC236}">
                  <a16:creationId xmlns:a16="http://schemas.microsoft.com/office/drawing/2014/main" id="{1089ECC7-7073-967C-2649-A77443416A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87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9" name="Rectangle 106">
              <a:extLst>
                <a:ext uri="{FF2B5EF4-FFF2-40B4-BE49-F238E27FC236}">
                  <a16:creationId xmlns:a16="http://schemas.microsoft.com/office/drawing/2014/main" id="{23518B51-2A96-9B14-F5C1-69E855E1D1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8" y="1844"/>
              <a:ext cx="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Rectangle 107">
              <a:extLst>
                <a:ext uri="{FF2B5EF4-FFF2-40B4-BE49-F238E27FC236}">
                  <a16:creationId xmlns:a16="http://schemas.microsoft.com/office/drawing/2014/main" id="{999B8429-836F-46BC-065A-D0401C93BB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5" y="1932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Rectangle 108">
              <a:extLst>
                <a:ext uri="{FF2B5EF4-FFF2-40B4-BE49-F238E27FC236}">
                  <a16:creationId xmlns:a16="http://schemas.microsoft.com/office/drawing/2014/main" id="{A3530C46-9ACC-77D3-DB4D-761809F173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98" y="1932"/>
              <a:ext cx="86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 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74409154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5</Words>
  <Application>Microsoft Office PowerPoint</Application>
  <PresentationFormat>宽屏</PresentationFormat>
  <Paragraphs>8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5</cp:revision>
  <dcterms:created xsi:type="dcterms:W3CDTF">2023-08-09T12:44:00Z</dcterms:created>
  <dcterms:modified xsi:type="dcterms:W3CDTF">2026-02-06T16:00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